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drawings/drawing1.xml" ContentType="application/vnd.openxmlformats-officedocument.drawingml.chartshapes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50" d="100"/>
          <a:sy n="150" d="100"/>
        </p:scale>
        <p:origin x="36" y="195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C:\Users\saguilar\Desktop\transCP\absolute%20expression%20all%20genes%202may2012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autoTitleDeleted val="1"/>
    <c:plotArea>
      <c:layout>
        <c:manualLayout>
          <c:layoutTarget val="inner"/>
          <c:xMode val="edge"/>
          <c:yMode val="edge"/>
          <c:x val="0.11320754716981134"/>
          <c:y val="0.12234910277324634"/>
          <c:w val="0.8756936736958939"/>
          <c:h val="0.75367047308319768"/>
        </c:manualLayout>
      </c:layout>
      <c:barChart>
        <c:barDir val="col"/>
        <c:grouping val="clustered"/>
        <c:ser>
          <c:idx val="0"/>
          <c:order val="0"/>
          <c:tx>
            <c:strRef>
              <c:f>Sheet1!$B$1</c:f>
              <c:strCache>
                <c:ptCount val="1"/>
                <c:pt idx="0">
                  <c:v>Florida</c:v>
                </c:pt>
              </c:strCache>
            </c:strRef>
          </c:tx>
          <c:spPr>
            <a:solidFill>
              <a:srgbClr val="000000"/>
            </a:solidFill>
            <a:ln w="12700">
              <a:solidFill>
                <a:srgbClr val="000000"/>
              </a:solidFill>
              <a:prstDash val="solid"/>
            </a:ln>
          </c:spPr>
          <c:cat>
            <c:strRef>
              <c:f>Sheet1!$A$2:$A$28</c:f>
              <c:strCache>
                <c:ptCount val="27"/>
                <c:pt idx="0">
                  <c:v>AMF_171</c:v>
                </c:pt>
                <c:pt idx="1">
                  <c:v>AMF_051</c:v>
                </c:pt>
                <c:pt idx="2">
                  <c:v>AMF_197</c:v>
                </c:pt>
                <c:pt idx="3">
                  <c:v>AMF_265</c:v>
                </c:pt>
                <c:pt idx="4">
                  <c:v>AMF_398</c:v>
                </c:pt>
                <c:pt idx="5">
                  <c:v>AMF_473</c:v>
                </c:pt>
                <c:pt idx="6">
                  <c:v>AMF_474</c:v>
                </c:pt>
                <c:pt idx="7">
                  <c:v>AMF_480</c:v>
                </c:pt>
                <c:pt idx="8">
                  <c:v>AMF_505</c:v>
                </c:pt>
                <c:pt idx="9">
                  <c:v>AMF_518</c:v>
                </c:pt>
                <c:pt idx="10">
                  <c:v>AMF_519</c:v>
                </c:pt>
                <c:pt idx="11">
                  <c:v>AMF_530</c:v>
                </c:pt>
                <c:pt idx="12">
                  <c:v>AMF_547</c:v>
                </c:pt>
                <c:pt idx="13">
                  <c:v>AMF_553</c:v>
                </c:pt>
                <c:pt idx="14">
                  <c:v>AMF_613</c:v>
                </c:pt>
                <c:pt idx="15">
                  <c:v>AMF_623</c:v>
                </c:pt>
                <c:pt idx="16">
                  <c:v>AMF_703</c:v>
                </c:pt>
                <c:pt idx="17">
                  <c:v>AMF_705</c:v>
                </c:pt>
                <c:pt idx="18">
                  <c:v>AMF_716</c:v>
                </c:pt>
                <c:pt idx="19">
                  <c:v>AMF_762</c:v>
                </c:pt>
                <c:pt idx="20">
                  <c:v>AMF_764</c:v>
                </c:pt>
                <c:pt idx="21">
                  <c:v>AMF_793</c:v>
                </c:pt>
                <c:pt idx="22">
                  <c:v>AMF_824</c:v>
                </c:pt>
                <c:pt idx="23">
                  <c:v>AMF_893</c:v>
                </c:pt>
                <c:pt idx="24">
                  <c:v>AMF_922</c:v>
                </c:pt>
                <c:pt idx="25">
                  <c:v>AMF_1026</c:v>
                </c:pt>
                <c:pt idx="26">
                  <c:v>AMF_1037</c:v>
                </c:pt>
              </c:strCache>
            </c:strRef>
          </c:cat>
          <c:val>
            <c:numRef>
              <c:f>Sheet1!$B$2:$B$28</c:f>
              <c:numCache>
                <c:formatCode>0.00E+00</c:formatCode>
                <c:ptCount val="27"/>
                <c:pt idx="0">
                  <c:v>3230000</c:v>
                </c:pt>
                <c:pt idx="1">
                  <c:v>13000000</c:v>
                </c:pt>
                <c:pt idx="2">
                  <c:v>297000</c:v>
                </c:pt>
                <c:pt idx="3">
                  <c:v>1450000</c:v>
                </c:pt>
                <c:pt idx="4">
                  <c:v>30300</c:v>
                </c:pt>
                <c:pt idx="5">
                  <c:v>22500000</c:v>
                </c:pt>
                <c:pt idx="6">
                  <c:v>14400000</c:v>
                </c:pt>
                <c:pt idx="7">
                  <c:v>7600000</c:v>
                </c:pt>
                <c:pt idx="8">
                  <c:v>904000</c:v>
                </c:pt>
                <c:pt idx="9">
                  <c:v>845000</c:v>
                </c:pt>
                <c:pt idx="10">
                  <c:v>3710000</c:v>
                </c:pt>
                <c:pt idx="11">
                  <c:v>44700000</c:v>
                </c:pt>
                <c:pt idx="12">
                  <c:v>16600000</c:v>
                </c:pt>
                <c:pt idx="13">
                  <c:v>32100000</c:v>
                </c:pt>
                <c:pt idx="14">
                  <c:v>72500</c:v>
                </c:pt>
                <c:pt idx="15">
                  <c:v>24600000</c:v>
                </c:pt>
                <c:pt idx="16">
                  <c:v>22000000</c:v>
                </c:pt>
                <c:pt idx="17">
                  <c:v>7330000</c:v>
                </c:pt>
                <c:pt idx="18">
                  <c:v>817000</c:v>
                </c:pt>
                <c:pt idx="19">
                  <c:v>2030000</c:v>
                </c:pt>
                <c:pt idx="20">
                  <c:v>3790000</c:v>
                </c:pt>
                <c:pt idx="21">
                  <c:v>18200000</c:v>
                </c:pt>
                <c:pt idx="22">
                  <c:v>4990000</c:v>
                </c:pt>
                <c:pt idx="23">
                  <c:v>8100000</c:v>
                </c:pt>
                <c:pt idx="24">
                  <c:v>76300000</c:v>
                </c:pt>
                <c:pt idx="25">
                  <c:v>2520000</c:v>
                </c:pt>
                <c:pt idx="26">
                  <c:v>72400</c:v>
                </c:pt>
              </c:numCache>
            </c:numRef>
          </c:val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St.Maries</c:v>
                </c:pt>
              </c:strCache>
            </c:strRef>
          </c:tx>
          <c:spPr>
            <a:solidFill>
              <a:srgbClr val="FFFFFF"/>
            </a:solidFill>
            <a:ln w="12700">
              <a:solidFill>
                <a:srgbClr val="000000"/>
              </a:solidFill>
              <a:prstDash val="solid"/>
            </a:ln>
          </c:spPr>
          <c:cat>
            <c:strRef>
              <c:f>Sheet1!$A$2:$A$28</c:f>
              <c:strCache>
                <c:ptCount val="27"/>
                <c:pt idx="0">
                  <c:v>AMF_171</c:v>
                </c:pt>
                <c:pt idx="1">
                  <c:v>AMF_051</c:v>
                </c:pt>
                <c:pt idx="2">
                  <c:v>AMF_197</c:v>
                </c:pt>
                <c:pt idx="3">
                  <c:v>AMF_265</c:v>
                </c:pt>
                <c:pt idx="4">
                  <c:v>AMF_398</c:v>
                </c:pt>
                <c:pt idx="5">
                  <c:v>AMF_473</c:v>
                </c:pt>
                <c:pt idx="6">
                  <c:v>AMF_474</c:v>
                </c:pt>
                <c:pt idx="7">
                  <c:v>AMF_480</c:v>
                </c:pt>
                <c:pt idx="8">
                  <c:v>AMF_505</c:v>
                </c:pt>
                <c:pt idx="9">
                  <c:v>AMF_518</c:v>
                </c:pt>
                <c:pt idx="10">
                  <c:v>AMF_519</c:v>
                </c:pt>
                <c:pt idx="11">
                  <c:v>AMF_530</c:v>
                </c:pt>
                <c:pt idx="12">
                  <c:v>AMF_547</c:v>
                </c:pt>
                <c:pt idx="13">
                  <c:v>AMF_553</c:v>
                </c:pt>
                <c:pt idx="14">
                  <c:v>AMF_613</c:v>
                </c:pt>
                <c:pt idx="15">
                  <c:v>AMF_623</c:v>
                </c:pt>
                <c:pt idx="16">
                  <c:v>AMF_703</c:v>
                </c:pt>
                <c:pt idx="17">
                  <c:v>AMF_705</c:v>
                </c:pt>
                <c:pt idx="18">
                  <c:v>AMF_716</c:v>
                </c:pt>
                <c:pt idx="19">
                  <c:v>AMF_762</c:v>
                </c:pt>
                <c:pt idx="20">
                  <c:v>AMF_764</c:v>
                </c:pt>
                <c:pt idx="21">
                  <c:v>AMF_793</c:v>
                </c:pt>
                <c:pt idx="22">
                  <c:v>AMF_824</c:v>
                </c:pt>
                <c:pt idx="23">
                  <c:v>AMF_893</c:v>
                </c:pt>
                <c:pt idx="24">
                  <c:v>AMF_922</c:v>
                </c:pt>
                <c:pt idx="25">
                  <c:v>AMF_1026</c:v>
                </c:pt>
                <c:pt idx="26">
                  <c:v>AMF_1037</c:v>
                </c:pt>
              </c:strCache>
            </c:strRef>
          </c:cat>
          <c:val>
            <c:numRef>
              <c:f>Sheet1!$C$2:$C$28</c:f>
              <c:numCache>
                <c:formatCode>0.00E+00</c:formatCode>
                <c:ptCount val="27"/>
                <c:pt idx="0">
                  <c:v>724000</c:v>
                </c:pt>
                <c:pt idx="1">
                  <c:v>16200000</c:v>
                </c:pt>
                <c:pt idx="2">
                  <c:v>1360000</c:v>
                </c:pt>
                <c:pt idx="3">
                  <c:v>3520000</c:v>
                </c:pt>
                <c:pt idx="4">
                  <c:v>7990</c:v>
                </c:pt>
                <c:pt idx="5">
                  <c:v>204000</c:v>
                </c:pt>
                <c:pt idx="6">
                  <c:v>618000</c:v>
                </c:pt>
                <c:pt idx="7">
                  <c:v>90000000</c:v>
                </c:pt>
                <c:pt idx="8">
                  <c:v>67400</c:v>
                </c:pt>
                <c:pt idx="9">
                  <c:v>285000</c:v>
                </c:pt>
                <c:pt idx="10">
                  <c:v>292000</c:v>
                </c:pt>
                <c:pt idx="11">
                  <c:v>5710000</c:v>
                </c:pt>
                <c:pt idx="12">
                  <c:v>2440000</c:v>
                </c:pt>
                <c:pt idx="13">
                  <c:v>48100000</c:v>
                </c:pt>
                <c:pt idx="14">
                  <c:v>57700</c:v>
                </c:pt>
                <c:pt idx="15">
                  <c:v>951000</c:v>
                </c:pt>
                <c:pt idx="16">
                  <c:v>237000000</c:v>
                </c:pt>
                <c:pt idx="17">
                  <c:v>5090000</c:v>
                </c:pt>
                <c:pt idx="18">
                  <c:v>241000</c:v>
                </c:pt>
                <c:pt idx="19">
                  <c:v>6340000</c:v>
                </c:pt>
                <c:pt idx="20">
                  <c:v>21900000</c:v>
                </c:pt>
                <c:pt idx="21">
                  <c:v>576000</c:v>
                </c:pt>
                <c:pt idx="22">
                  <c:v>10400000</c:v>
                </c:pt>
                <c:pt idx="23">
                  <c:v>40700000</c:v>
                </c:pt>
                <c:pt idx="24">
                  <c:v>11800000</c:v>
                </c:pt>
                <c:pt idx="25">
                  <c:v>11600000</c:v>
                </c:pt>
                <c:pt idx="26">
                  <c:v>654000</c:v>
                </c:pt>
              </c:numCache>
            </c:numRef>
          </c:val>
        </c:ser>
        <c:dLbls/>
        <c:axId val="48276608"/>
        <c:axId val="48278144"/>
      </c:barChart>
      <c:catAx>
        <c:axId val="48276608"/>
        <c:scaling>
          <c:orientation val="minMax"/>
        </c:scaling>
        <c:axPos val="b"/>
        <c:numFmt formatCode="General" sourceLinked="1"/>
        <c:tickLblPos val="nextTo"/>
        <c:spPr>
          <a:ln w="3175">
            <a:solidFill>
              <a:srgbClr val="000000"/>
            </a:solidFill>
            <a:prstDash val="solid"/>
          </a:ln>
        </c:spPr>
        <c:txPr>
          <a:bodyPr rot="-270000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48278144"/>
        <c:crosses val="autoZero"/>
        <c:auto val="1"/>
        <c:lblAlgn val="ctr"/>
        <c:lblOffset val="100"/>
        <c:tickLblSkip val="1"/>
        <c:tickMarkSkip val="1"/>
      </c:catAx>
      <c:valAx>
        <c:axId val="48278144"/>
        <c:scaling>
          <c:logBase val="10"/>
          <c:orientation val="minMax"/>
        </c:scaling>
        <c:axPos val="l"/>
        <c:majorGridlines>
          <c:spPr>
            <a:ln w="3175">
              <a:solidFill>
                <a:srgbClr val="000000"/>
              </a:solidFill>
              <a:prstDash val="solid"/>
            </a:ln>
          </c:spPr>
        </c:majorGridlines>
        <c:numFmt formatCode="0.00E+00" sourceLinked="0"/>
        <c:tickLblPos val="none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1000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48276608"/>
        <c:crosses val="autoZero"/>
        <c:crossBetween val="between"/>
      </c:valAx>
      <c:spPr>
        <a:solidFill>
          <a:srgbClr val="FFFFFF"/>
        </a:solidFill>
        <a:ln w="12700">
          <a:solidFill>
            <a:srgbClr val="808080"/>
          </a:solidFill>
          <a:prstDash val="solid"/>
        </a:ln>
      </c:spPr>
    </c:plotArea>
    <c:plotVisOnly val="1"/>
    <c:dispBlanksAs val="gap"/>
  </c:chart>
  <c:spPr>
    <a:noFill/>
    <a:ln w="9525">
      <a:noFill/>
    </a:ln>
  </c:spPr>
  <c:txPr>
    <a:bodyPr/>
    <a:lstStyle/>
    <a:p>
      <a:pPr>
        <a:defRPr sz="1000" b="0" i="0" u="none" strike="noStrike" baseline="0">
          <a:solidFill>
            <a:srgbClr val="000000"/>
          </a:solidFill>
          <a:latin typeface="Arial"/>
          <a:ea typeface="Arial"/>
          <a:cs typeface="Arial"/>
        </a:defRPr>
      </a:pPr>
      <a:endParaRPr lang="en-US"/>
    </a:p>
  </c:txPr>
  <c:externalData r:id="rId1"/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09883</cdr:x>
      <cdr:y>0.07752</cdr:y>
    </cdr:from>
    <cdr:to>
      <cdr:x>0.13836</cdr:x>
      <cdr:y>0.13566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571500" y="304800"/>
          <a:ext cx="228600" cy="2286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pPr algn="ctr"/>
          <a:r>
            <a:rPr lang="en-US" dirty="0" smtClean="0">
              <a:latin typeface="Arial" pitchFamily="34" charset="0"/>
              <a:cs typeface="Arial" pitchFamily="34" charset="0"/>
            </a:rPr>
            <a:t>9</a:t>
          </a:r>
        </a:p>
        <a:p xmlns:a="http://schemas.openxmlformats.org/drawingml/2006/main">
          <a:endParaRPr lang="es-MX" sz="1100" dirty="0"/>
        </a:p>
      </cdr:txBody>
    </cdr:sp>
  </cdr:relSizeAnchor>
  <cdr:relSizeAnchor xmlns:cdr="http://schemas.openxmlformats.org/drawingml/2006/chartDrawing">
    <cdr:from>
      <cdr:x>0.09883</cdr:x>
      <cdr:y>0.15289</cdr:y>
    </cdr:from>
    <cdr:to>
      <cdr:x>0.13836</cdr:x>
      <cdr:y>0.21102</cdr:y>
    </cdr:to>
    <cdr:sp macro="" textlink="">
      <cdr:nvSpPr>
        <cdr:cNvPr id="3" name="TextBox 1"/>
        <cdr:cNvSpPr txBox="1"/>
      </cdr:nvSpPr>
      <cdr:spPr>
        <a:xfrm xmlns:a="http://schemas.openxmlformats.org/drawingml/2006/main">
          <a:off x="571500" y="601133"/>
          <a:ext cx="228600" cy="2286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US" dirty="0" smtClean="0">
              <a:latin typeface="Arial" pitchFamily="34" charset="0"/>
              <a:cs typeface="Arial" pitchFamily="34" charset="0"/>
            </a:rPr>
            <a:t>8</a:t>
          </a:r>
        </a:p>
        <a:p xmlns:a="http://schemas.openxmlformats.org/drawingml/2006/main">
          <a:endParaRPr lang="es-MX" sz="1100" dirty="0"/>
        </a:p>
      </cdr:txBody>
    </cdr:sp>
  </cdr:relSizeAnchor>
  <cdr:relSizeAnchor xmlns:cdr="http://schemas.openxmlformats.org/drawingml/2006/chartDrawing">
    <cdr:from>
      <cdr:x>0.09883</cdr:x>
      <cdr:y>0.22825</cdr:y>
    </cdr:from>
    <cdr:to>
      <cdr:x>0.13836</cdr:x>
      <cdr:y>0.28639</cdr:y>
    </cdr:to>
    <cdr:sp macro="" textlink="">
      <cdr:nvSpPr>
        <cdr:cNvPr id="4" name="TextBox 1"/>
        <cdr:cNvSpPr txBox="1"/>
      </cdr:nvSpPr>
      <cdr:spPr>
        <a:xfrm xmlns:a="http://schemas.openxmlformats.org/drawingml/2006/main">
          <a:off x="571500" y="897466"/>
          <a:ext cx="228600" cy="2286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US" dirty="0">
              <a:latin typeface="Arial" pitchFamily="34" charset="0"/>
              <a:cs typeface="Arial" pitchFamily="34" charset="0"/>
            </a:rPr>
            <a:t>7</a:t>
          </a:r>
          <a:endParaRPr lang="en-US" dirty="0" smtClean="0">
            <a:latin typeface="Arial" pitchFamily="34" charset="0"/>
            <a:cs typeface="Arial" pitchFamily="34" charset="0"/>
          </a:endParaRPr>
        </a:p>
        <a:p xmlns:a="http://schemas.openxmlformats.org/drawingml/2006/main">
          <a:endParaRPr lang="es-MX" sz="1100" dirty="0"/>
        </a:p>
      </cdr:txBody>
    </cdr:sp>
  </cdr:relSizeAnchor>
  <cdr:relSizeAnchor xmlns:cdr="http://schemas.openxmlformats.org/drawingml/2006/chartDrawing">
    <cdr:from>
      <cdr:x>0.09883</cdr:x>
      <cdr:y>0.30362</cdr:y>
    </cdr:from>
    <cdr:to>
      <cdr:x>0.13836</cdr:x>
      <cdr:y>0.36176</cdr:y>
    </cdr:to>
    <cdr:sp macro="" textlink="">
      <cdr:nvSpPr>
        <cdr:cNvPr id="5" name="TextBox 1"/>
        <cdr:cNvSpPr txBox="1"/>
      </cdr:nvSpPr>
      <cdr:spPr>
        <a:xfrm xmlns:a="http://schemas.openxmlformats.org/drawingml/2006/main">
          <a:off x="571500" y="1193799"/>
          <a:ext cx="228600" cy="2286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US" dirty="0">
              <a:latin typeface="Arial" pitchFamily="34" charset="0"/>
              <a:cs typeface="Arial" pitchFamily="34" charset="0"/>
            </a:rPr>
            <a:t>6</a:t>
          </a:r>
          <a:endParaRPr lang="en-US" dirty="0" smtClean="0">
            <a:latin typeface="Arial" pitchFamily="34" charset="0"/>
            <a:cs typeface="Arial" pitchFamily="34" charset="0"/>
          </a:endParaRPr>
        </a:p>
        <a:p xmlns:a="http://schemas.openxmlformats.org/drawingml/2006/main">
          <a:endParaRPr lang="es-MX" sz="1100" dirty="0"/>
        </a:p>
      </cdr:txBody>
    </cdr:sp>
  </cdr:relSizeAnchor>
  <cdr:relSizeAnchor xmlns:cdr="http://schemas.openxmlformats.org/drawingml/2006/chartDrawing">
    <cdr:from>
      <cdr:x>0.09883</cdr:x>
      <cdr:y>0.37898</cdr:y>
    </cdr:from>
    <cdr:to>
      <cdr:x>0.13836</cdr:x>
      <cdr:y>0.43712</cdr:y>
    </cdr:to>
    <cdr:sp macro="" textlink="">
      <cdr:nvSpPr>
        <cdr:cNvPr id="7" name="TextBox 1"/>
        <cdr:cNvSpPr txBox="1"/>
      </cdr:nvSpPr>
      <cdr:spPr>
        <a:xfrm xmlns:a="http://schemas.openxmlformats.org/drawingml/2006/main">
          <a:off x="571500" y="1490132"/>
          <a:ext cx="228600" cy="2286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US" dirty="0">
              <a:latin typeface="Arial" pitchFamily="34" charset="0"/>
              <a:cs typeface="Arial" pitchFamily="34" charset="0"/>
            </a:rPr>
            <a:t>5</a:t>
          </a:r>
          <a:endParaRPr lang="en-US" dirty="0" smtClean="0">
            <a:latin typeface="Arial" pitchFamily="34" charset="0"/>
            <a:cs typeface="Arial" pitchFamily="34" charset="0"/>
          </a:endParaRPr>
        </a:p>
        <a:p xmlns:a="http://schemas.openxmlformats.org/drawingml/2006/main">
          <a:endParaRPr lang="es-MX" sz="1100" dirty="0"/>
        </a:p>
      </cdr:txBody>
    </cdr:sp>
  </cdr:relSizeAnchor>
  <cdr:relSizeAnchor xmlns:cdr="http://schemas.openxmlformats.org/drawingml/2006/chartDrawing">
    <cdr:from>
      <cdr:x>0.09883</cdr:x>
      <cdr:y>0.45435</cdr:y>
    </cdr:from>
    <cdr:to>
      <cdr:x>0.13836</cdr:x>
      <cdr:y>0.51249</cdr:y>
    </cdr:to>
    <cdr:sp macro="" textlink="">
      <cdr:nvSpPr>
        <cdr:cNvPr id="9" name="TextBox 1"/>
        <cdr:cNvSpPr txBox="1"/>
      </cdr:nvSpPr>
      <cdr:spPr>
        <a:xfrm xmlns:a="http://schemas.openxmlformats.org/drawingml/2006/main">
          <a:off x="571500" y="1786465"/>
          <a:ext cx="228600" cy="2286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US" dirty="0">
              <a:latin typeface="Arial" pitchFamily="34" charset="0"/>
              <a:cs typeface="Arial" pitchFamily="34" charset="0"/>
            </a:rPr>
            <a:t>4</a:t>
          </a:r>
          <a:endParaRPr lang="en-US" dirty="0" smtClean="0">
            <a:latin typeface="Arial" pitchFamily="34" charset="0"/>
            <a:cs typeface="Arial" pitchFamily="34" charset="0"/>
          </a:endParaRPr>
        </a:p>
        <a:p xmlns:a="http://schemas.openxmlformats.org/drawingml/2006/main">
          <a:endParaRPr lang="es-MX" sz="1100" dirty="0"/>
        </a:p>
      </cdr:txBody>
    </cdr:sp>
  </cdr:relSizeAnchor>
  <cdr:relSizeAnchor xmlns:cdr="http://schemas.openxmlformats.org/drawingml/2006/chartDrawing">
    <cdr:from>
      <cdr:x>0.09883</cdr:x>
      <cdr:y>0.52972</cdr:y>
    </cdr:from>
    <cdr:to>
      <cdr:x>0.13836</cdr:x>
      <cdr:y>0.58785</cdr:y>
    </cdr:to>
    <cdr:sp macro="" textlink="">
      <cdr:nvSpPr>
        <cdr:cNvPr id="10" name="TextBox 1"/>
        <cdr:cNvSpPr txBox="1"/>
      </cdr:nvSpPr>
      <cdr:spPr>
        <a:xfrm xmlns:a="http://schemas.openxmlformats.org/drawingml/2006/main">
          <a:off x="571500" y="2082798"/>
          <a:ext cx="228600" cy="2286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US" dirty="0">
              <a:latin typeface="Arial" pitchFamily="34" charset="0"/>
              <a:cs typeface="Arial" pitchFamily="34" charset="0"/>
            </a:rPr>
            <a:t>3</a:t>
          </a:r>
          <a:endParaRPr lang="en-US" dirty="0" smtClean="0">
            <a:latin typeface="Arial" pitchFamily="34" charset="0"/>
            <a:cs typeface="Arial" pitchFamily="34" charset="0"/>
          </a:endParaRPr>
        </a:p>
        <a:p xmlns:a="http://schemas.openxmlformats.org/drawingml/2006/main">
          <a:endParaRPr lang="es-MX" sz="1100" dirty="0"/>
        </a:p>
      </cdr:txBody>
    </cdr:sp>
  </cdr:relSizeAnchor>
  <cdr:relSizeAnchor xmlns:cdr="http://schemas.openxmlformats.org/drawingml/2006/chartDrawing">
    <cdr:from>
      <cdr:x>0.09883</cdr:x>
      <cdr:y>0.60508</cdr:y>
    </cdr:from>
    <cdr:to>
      <cdr:x>0.13836</cdr:x>
      <cdr:y>0.66322</cdr:y>
    </cdr:to>
    <cdr:sp macro="" textlink="">
      <cdr:nvSpPr>
        <cdr:cNvPr id="11" name="TextBox 1"/>
        <cdr:cNvSpPr txBox="1"/>
      </cdr:nvSpPr>
      <cdr:spPr>
        <a:xfrm xmlns:a="http://schemas.openxmlformats.org/drawingml/2006/main">
          <a:off x="571500" y="2379131"/>
          <a:ext cx="228600" cy="2286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US" dirty="0">
              <a:latin typeface="Arial" pitchFamily="34" charset="0"/>
              <a:cs typeface="Arial" pitchFamily="34" charset="0"/>
            </a:rPr>
            <a:t>2</a:t>
          </a:r>
          <a:endParaRPr lang="en-US" dirty="0" smtClean="0">
            <a:latin typeface="Arial" pitchFamily="34" charset="0"/>
            <a:cs typeface="Arial" pitchFamily="34" charset="0"/>
          </a:endParaRPr>
        </a:p>
        <a:p xmlns:a="http://schemas.openxmlformats.org/drawingml/2006/main">
          <a:endParaRPr lang="es-MX" sz="1100" dirty="0"/>
        </a:p>
      </cdr:txBody>
    </cdr:sp>
  </cdr:relSizeAnchor>
  <cdr:relSizeAnchor xmlns:cdr="http://schemas.openxmlformats.org/drawingml/2006/chartDrawing">
    <cdr:from>
      <cdr:x>0.09883</cdr:x>
      <cdr:y>0.68045</cdr:y>
    </cdr:from>
    <cdr:to>
      <cdr:x>0.13836</cdr:x>
      <cdr:y>0.73859</cdr:y>
    </cdr:to>
    <cdr:sp macro="" textlink="">
      <cdr:nvSpPr>
        <cdr:cNvPr id="12" name="TextBox 1"/>
        <cdr:cNvSpPr txBox="1"/>
      </cdr:nvSpPr>
      <cdr:spPr>
        <a:xfrm xmlns:a="http://schemas.openxmlformats.org/drawingml/2006/main">
          <a:off x="571500" y="2675464"/>
          <a:ext cx="228600" cy="2286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US" dirty="0">
              <a:latin typeface="Arial" pitchFamily="34" charset="0"/>
              <a:cs typeface="Arial" pitchFamily="34" charset="0"/>
            </a:rPr>
            <a:t>1</a:t>
          </a:r>
          <a:endParaRPr lang="en-US" dirty="0" smtClean="0">
            <a:latin typeface="Arial" pitchFamily="34" charset="0"/>
            <a:cs typeface="Arial" pitchFamily="34" charset="0"/>
          </a:endParaRPr>
        </a:p>
        <a:p xmlns:a="http://schemas.openxmlformats.org/drawingml/2006/main">
          <a:endParaRPr lang="es-MX" sz="1100" dirty="0"/>
        </a:p>
      </cdr:txBody>
    </cdr:sp>
  </cdr:relSizeAnchor>
  <cdr:relSizeAnchor xmlns:cdr="http://schemas.openxmlformats.org/drawingml/2006/chartDrawing">
    <cdr:from>
      <cdr:x>0.09883</cdr:x>
      <cdr:y>0.75581</cdr:y>
    </cdr:from>
    <cdr:to>
      <cdr:x>0.13836</cdr:x>
      <cdr:y>0.81395</cdr:y>
    </cdr:to>
    <cdr:sp macro="" textlink="">
      <cdr:nvSpPr>
        <cdr:cNvPr id="13" name="TextBox 1"/>
        <cdr:cNvSpPr txBox="1"/>
      </cdr:nvSpPr>
      <cdr:spPr>
        <a:xfrm xmlns:a="http://schemas.openxmlformats.org/drawingml/2006/main">
          <a:off x="571500" y="2971800"/>
          <a:ext cx="228600" cy="2286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US" dirty="0" smtClean="0">
              <a:latin typeface="Arial" pitchFamily="34" charset="0"/>
              <a:cs typeface="Arial" pitchFamily="34" charset="0"/>
            </a:rPr>
            <a:t>0</a:t>
          </a:r>
        </a:p>
        <a:p xmlns:a="http://schemas.openxmlformats.org/drawingml/2006/main">
          <a:endParaRPr lang="es-MX" sz="1100" dirty="0"/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s-MX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s-MX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7EE3F4-F562-4832-A5E2-9B23983B606B}" type="datetimeFigureOut">
              <a:rPr lang="es-MX" smtClean="0"/>
              <a:pPr/>
              <a:t>22/06/2012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ACD865-5EBB-476D-B642-096B8EB5AE3D}" type="slidenum">
              <a:rPr lang="es-MX" smtClean="0"/>
              <a:pPr/>
              <a:t>‹#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xmlns="" val="25059104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s-MX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MX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7EE3F4-F562-4832-A5E2-9B23983B606B}" type="datetimeFigureOut">
              <a:rPr lang="es-MX" smtClean="0"/>
              <a:pPr/>
              <a:t>22/06/2012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ACD865-5EBB-476D-B642-096B8EB5AE3D}" type="slidenum">
              <a:rPr lang="es-MX" smtClean="0"/>
              <a:pPr/>
              <a:t>‹#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xmlns="" val="39773987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s-MX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MX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7EE3F4-F562-4832-A5E2-9B23983B606B}" type="datetimeFigureOut">
              <a:rPr lang="es-MX" smtClean="0"/>
              <a:pPr/>
              <a:t>22/06/2012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ACD865-5EBB-476D-B642-096B8EB5AE3D}" type="slidenum">
              <a:rPr lang="es-MX" smtClean="0"/>
              <a:pPr/>
              <a:t>‹#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xmlns="" val="22762478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s-MX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MX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7EE3F4-F562-4832-A5E2-9B23983B606B}" type="datetimeFigureOut">
              <a:rPr lang="es-MX" smtClean="0"/>
              <a:pPr/>
              <a:t>22/06/2012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ACD865-5EBB-476D-B642-096B8EB5AE3D}" type="slidenum">
              <a:rPr lang="es-MX" smtClean="0"/>
              <a:pPr/>
              <a:t>‹#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xmlns="" val="5289921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s-MX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7EE3F4-F562-4832-A5E2-9B23983B606B}" type="datetimeFigureOut">
              <a:rPr lang="es-MX" smtClean="0"/>
              <a:pPr/>
              <a:t>22/06/2012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ACD865-5EBB-476D-B642-096B8EB5AE3D}" type="slidenum">
              <a:rPr lang="es-MX" smtClean="0"/>
              <a:pPr/>
              <a:t>‹#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xmlns="" val="2836263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s-MX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MX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MX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7EE3F4-F562-4832-A5E2-9B23983B606B}" type="datetimeFigureOut">
              <a:rPr lang="es-MX" smtClean="0"/>
              <a:pPr/>
              <a:t>22/06/2012</a:t>
            </a:fld>
            <a:endParaRPr lang="es-MX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ACD865-5EBB-476D-B642-096B8EB5AE3D}" type="slidenum">
              <a:rPr lang="es-MX" smtClean="0"/>
              <a:pPr/>
              <a:t>‹#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xmlns="" val="14406896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s-MX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MX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MX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7EE3F4-F562-4832-A5E2-9B23983B606B}" type="datetimeFigureOut">
              <a:rPr lang="es-MX" smtClean="0"/>
              <a:pPr/>
              <a:t>22/06/2012</a:t>
            </a:fld>
            <a:endParaRPr lang="es-MX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ACD865-5EBB-476D-B642-096B8EB5AE3D}" type="slidenum">
              <a:rPr lang="es-MX" smtClean="0"/>
              <a:pPr/>
              <a:t>‹#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xmlns="" val="32422681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s-MX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7EE3F4-F562-4832-A5E2-9B23983B606B}" type="datetimeFigureOut">
              <a:rPr lang="es-MX" smtClean="0"/>
              <a:pPr/>
              <a:t>22/06/2012</a:t>
            </a:fld>
            <a:endParaRPr lang="es-MX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ACD865-5EBB-476D-B642-096B8EB5AE3D}" type="slidenum">
              <a:rPr lang="es-MX" smtClean="0"/>
              <a:pPr/>
              <a:t>‹#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xmlns="" val="12093658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7EE3F4-F562-4832-A5E2-9B23983B606B}" type="datetimeFigureOut">
              <a:rPr lang="es-MX" smtClean="0"/>
              <a:pPr/>
              <a:t>22/06/2012</a:t>
            </a:fld>
            <a:endParaRPr lang="es-MX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ACD865-5EBB-476D-B642-096B8EB5AE3D}" type="slidenum">
              <a:rPr lang="es-MX" smtClean="0"/>
              <a:pPr/>
              <a:t>‹#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xmlns="" val="39189683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s-MX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MX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7EE3F4-F562-4832-A5E2-9B23983B606B}" type="datetimeFigureOut">
              <a:rPr lang="es-MX" smtClean="0"/>
              <a:pPr/>
              <a:t>22/06/2012</a:t>
            </a:fld>
            <a:endParaRPr lang="es-MX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ACD865-5EBB-476D-B642-096B8EB5AE3D}" type="slidenum">
              <a:rPr lang="es-MX" smtClean="0"/>
              <a:pPr/>
              <a:t>‹#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xmlns="" val="15186501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s-MX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MX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7EE3F4-F562-4832-A5E2-9B23983B606B}" type="datetimeFigureOut">
              <a:rPr lang="es-MX" smtClean="0"/>
              <a:pPr/>
              <a:t>22/06/2012</a:t>
            </a:fld>
            <a:endParaRPr lang="es-MX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ACD865-5EBB-476D-B642-096B8EB5AE3D}" type="slidenum">
              <a:rPr lang="es-MX" smtClean="0"/>
              <a:pPr/>
              <a:t>‹#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xmlns="" val="39875821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s-MX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MX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7EE3F4-F562-4832-A5E2-9B23983B606B}" type="datetimeFigureOut">
              <a:rPr lang="es-MX" smtClean="0"/>
              <a:pPr/>
              <a:t>22/06/2012</a:t>
            </a:fld>
            <a:endParaRPr lang="es-MX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MX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ACD865-5EBB-476D-B642-096B8EB5AE3D}" type="slidenum">
              <a:rPr lang="es-MX" smtClean="0"/>
              <a:pPr/>
              <a:t>‹#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xmlns="" val="20458782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 noGrp="1" noChangeAspect="1"/>
          </p:cNvGraphicFramePr>
          <p:nvPr>
            <p:extLst>
              <p:ext uri="{D42A27DB-BD31-4B8C-83A1-F6EECF244321}">
                <p14:modId xmlns:p14="http://schemas.microsoft.com/office/powerpoint/2010/main" xmlns="" val="129321365"/>
              </p:ext>
            </p:extLst>
          </p:nvPr>
        </p:nvGraphicFramePr>
        <p:xfrm>
          <a:off x="537603" y="2606040"/>
          <a:ext cx="5782794" cy="39319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TextBox 5"/>
          <p:cNvSpPr txBox="1"/>
          <p:nvPr/>
        </p:nvSpPr>
        <p:spPr>
          <a:xfrm rot="16200000">
            <a:off x="108465" y="4158735"/>
            <a:ext cx="16764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itchFamily="34" charset="0"/>
                <a:cs typeface="Arial" pitchFamily="34" charset="0"/>
              </a:rPr>
              <a:t>Copy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#(log</a:t>
            </a:r>
            <a:r>
              <a:rPr lang="en-US" sz="1000" baseline="-25000" dirty="0" smtClean="0">
                <a:latin typeface="Arial" pitchFamily="34" charset="0"/>
                <a:cs typeface="Arial" pitchFamily="34" charset="0"/>
              </a:rPr>
              <a:t>10</a:t>
            </a:r>
            <a:r>
              <a:rPr lang="en-US" sz="1000" dirty="0" smtClean="0">
                <a:latin typeface="Arial" pitchFamily="34" charset="0"/>
                <a:cs typeface="Arial" pitchFamily="34" charset="0"/>
              </a:rPr>
              <a:t>)/ml </a:t>
            </a:r>
            <a:r>
              <a:rPr lang="en-US" sz="1000" dirty="0">
                <a:latin typeface="Arial" pitchFamily="34" charset="0"/>
                <a:cs typeface="Arial" pitchFamily="34" charset="0"/>
              </a:rPr>
              <a:t>of blood</a:t>
            </a:r>
          </a:p>
          <a:p>
            <a:pPr algn="ctr"/>
            <a:endParaRPr lang="es-MX" sz="8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2884699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5</TotalTime>
  <Words>17</Words>
  <Application>Microsoft Office PowerPoint</Application>
  <PresentationFormat>On-screen Show (4:3)</PresentationFormat>
  <Paragraphs>1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Washington State University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guilar, Sebastian</dc:creator>
  <cp:lastModifiedBy>kbrayton</cp:lastModifiedBy>
  <cp:revision>10</cp:revision>
  <dcterms:created xsi:type="dcterms:W3CDTF">2012-05-02T02:14:32Z</dcterms:created>
  <dcterms:modified xsi:type="dcterms:W3CDTF">2012-06-22T18:39:19Z</dcterms:modified>
</cp:coreProperties>
</file>